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2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05"/>
    <p:restoredTop sz="95833"/>
  </p:normalViewPr>
  <p:slideViewPr>
    <p:cSldViewPr snapToGrid="0">
      <p:cViewPr>
        <p:scale>
          <a:sx n="90" d="100"/>
          <a:sy n="90" d="100"/>
        </p:scale>
        <p:origin x="184" y="6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956B22-E28A-D543-A189-82441F30D95B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9C0941-5BCA-684E-A936-B07DBE327E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1579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EF5F9A-E375-0FB3-FA4E-37606CC415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64A9A97-4284-01C0-A3F9-81E8B75A29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0F1986-3C68-70B2-2CED-2334B24E0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B014FD5-88C6-6727-1AD1-A0BB76C6E6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CF2278-6394-E9B4-56AA-8C2DEB304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6673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C3703B-D681-EB11-FE95-536B21C5F8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92AB2F4-C80B-671B-F7AB-DCF18EC556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4AE596B-0765-7728-20C1-32136057C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269101-DFDA-5BF7-6299-3B0CF06EC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ABB31F-1D2E-7BD7-0123-2A5F3ACC9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6724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1492B2D-AD81-62C7-95E5-060E8560C2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D3D90F-7FA0-E91E-049C-9B8E7FB278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175C21-1105-06B6-8A46-6014DFA9B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1F6C86A-5CFD-F685-B745-188E90995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2A6A9E-B663-2C5B-EED6-D195C4B4D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559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41B7FB-3CD5-6DA4-7180-C6B0E0B264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B9BFD70-2FCF-8109-D007-57DE4D4F84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76AF91-56DE-9F6E-1D7D-8461F4089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F0BF31E-276A-DBBE-BFC1-A5FD6FB73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6C0982-7872-9DE3-49E9-E397B982A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6257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2C43D0-B23A-295F-F8FA-6A7EB01B4D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E4F854A-CC6D-7D14-A271-6833B3D601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329928-092A-C2D4-E445-AC1E3B562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94FD888-B151-2C86-D79E-6B3891C3F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30126C-4C8A-C27D-92D2-AB05BAA50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8917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95C6D5-2227-4E27-1354-A4BC67F080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95FF750-EBA6-AEFB-93A9-5CF6DB1AC6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F05AB84-A98E-A04E-D0F7-645E743663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DDF955-7D4E-4117-1499-3841F98D54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307EED4-5664-6D4F-79E3-68FE7DD2E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605308A-77A5-9E9F-CBAF-1563710E5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151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A187A7-E80A-686C-2CB2-C5E638A6F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BE1FC36-4386-900D-B55D-77502D7EDD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59181A1-BEDA-36DA-B695-1197E4788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4597585-0A8A-7F2D-4FF5-513CA9DD7F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1E31DE4-05B8-43AF-40A8-D796A41897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7A8CE19-C4CF-1F8C-50B6-D4DF2B59C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AC63341-0810-BD28-53A9-96FB4C54DC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30B6D64-EA28-010C-8056-392CB6C48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74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CE1E43-0314-5A9D-7CCB-F13244A944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9D2D7CB-12C9-326C-3177-3C68B7394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CB3FAED-F59D-9F37-4A0C-6DB2BACF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05C783C-28CE-F964-E113-4612D0F53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4136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3552ADC-579C-EAA7-B4D9-0CB841248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E807842-8123-3192-C7F0-BC1B199C0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7961BE7-FEEA-3E2F-6992-559910F74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041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C0AAD3-8F44-1C97-359D-733745117C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67CA9FF-4CD1-0820-D4BE-D76DEC4DB7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D66D716-2A2A-0E5A-4C8D-8462981A0E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145B590-39F9-AF2A-D2F4-ECA390627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74F604E-A5EB-5094-88D4-33A52368A1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1CD982-CA3B-6FB1-C853-005EEB486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745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F574C3-3123-413F-0E19-3DE9EE6A1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BDB8882-3573-10C7-7793-057FE77241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024AC68-C9E5-3852-67F3-A644229435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0D12894-37FB-1BDB-7894-D7A2B5738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C033871-8B78-968B-D2EF-1580E6B2D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D1B566-3EA3-0B7C-4D4B-D7FC7F0551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8194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949A05E-5343-89CA-B360-BAAB68195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3D8E8D5-9688-6E5A-370E-24CF528DB7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4B47742-2EFD-E27F-ABED-A19E24F5EB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40B97-BF4F-F24E-A304-6C4B60892296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2111FA-92FC-5875-CD74-22AF75D77A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80839A-6F88-A81C-C525-CFD46F8E53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C1B5A5-63B0-B346-BB7E-33823889661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987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グラフ, ダイアグラム&#10;&#10;自動的に生成された説明">
            <a:extLst>
              <a:ext uri="{FF2B5EF4-FFF2-40B4-BE49-F238E27FC236}">
                <a16:creationId xmlns:a16="http://schemas.microsoft.com/office/drawing/2014/main" id="{FE94F4B8-DB6C-3A37-D893-B9A51AB5EA6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824" t="598" r="21920" b="54134"/>
          <a:stretch/>
        </p:blipFill>
        <p:spPr>
          <a:xfrm>
            <a:off x="0" y="1285875"/>
            <a:ext cx="6606194" cy="3600000"/>
          </a:xfrm>
          <a:prstGeom prst="rect">
            <a:avLst/>
          </a:prstGeom>
        </p:spPr>
      </p:pic>
      <p:pic>
        <p:nvPicPr>
          <p:cNvPr id="6" name="図 5" descr="グラフ, ダイアグラム&#10;&#10;自動的に生成された説明">
            <a:extLst>
              <a:ext uri="{FF2B5EF4-FFF2-40B4-BE49-F238E27FC236}">
                <a16:creationId xmlns:a16="http://schemas.microsoft.com/office/drawing/2014/main" id="{0BB27E1F-8186-B0B2-3BBF-8A5A7F82810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679" t="44878" r="21920" b="9854"/>
          <a:stretch/>
        </p:blipFill>
        <p:spPr>
          <a:xfrm>
            <a:off x="6606546" y="1285875"/>
            <a:ext cx="5585454" cy="36000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D8662DF-2E79-49CD-CB9E-FADC0BC49D4B}"/>
              </a:ext>
            </a:extLst>
          </p:cNvPr>
          <p:cNvSpPr txBox="1"/>
          <p:nvPr/>
        </p:nvSpPr>
        <p:spPr>
          <a:xfrm>
            <a:off x="-27251" y="381004"/>
            <a:ext cx="2762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Total AMPK alpha (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2k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3568FA2-4B66-CD7A-1894-828ABBC7AE10}"/>
              </a:ext>
            </a:extLst>
          </p:cNvPr>
          <p:cNvSpPr txBox="1"/>
          <p:nvPr/>
        </p:nvSpPr>
        <p:spPr>
          <a:xfrm>
            <a:off x="1343029" y="810781"/>
            <a:ext cx="9381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Met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Ra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811C5AD-1767-99FE-7DDD-C25F31937D81}"/>
              </a:ext>
            </a:extLst>
          </p:cNvPr>
          <p:cNvSpPr txBox="1"/>
          <p:nvPr/>
        </p:nvSpPr>
        <p:spPr>
          <a:xfrm>
            <a:off x="1949262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4F4733E-5343-FF60-077A-82F260D64257}"/>
              </a:ext>
            </a:extLst>
          </p:cNvPr>
          <p:cNvSpPr txBox="1"/>
          <p:nvPr/>
        </p:nvSpPr>
        <p:spPr>
          <a:xfrm>
            <a:off x="2421109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077287C-32AC-8004-7670-A6120F40BEA7}"/>
              </a:ext>
            </a:extLst>
          </p:cNvPr>
          <p:cNvSpPr txBox="1"/>
          <p:nvPr/>
        </p:nvSpPr>
        <p:spPr>
          <a:xfrm>
            <a:off x="2875342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CBBC250-E8A4-BBE5-9356-AFE5BE474FAC}"/>
              </a:ext>
            </a:extLst>
          </p:cNvPr>
          <p:cNvSpPr txBox="1"/>
          <p:nvPr/>
        </p:nvSpPr>
        <p:spPr>
          <a:xfrm>
            <a:off x="3309826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FE30F27-A2E9-28D4-D7B0-3DB1F0FBF296}"/>
              </a:ext>
            </a:extLst>
          </p:cNvPr>
          <p:cNvSpPr txBox="1"/>
          <p:nvPr/>
        </p:nvSpPr>
        <p:spPr>
          <a:xfrm>
            <a:off x="6607887" y="381004"/>
            <a:ext cx="4134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hospho-AMPK</a:t>
            </a:r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 alpha 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(Thr172)</a:t>
            </a:r>
            <a:r>
              <a:rPr lang="en-US" altLang="ja-JP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62k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4BE8C09-9F67-35CC-EE06-B5BC8D602AC5}"/>
              </a:ext>
            </a:extLst>
          </p:cNvPr>
          <p:cNvSpPr txBox="1"/>
          <p:nvPr/>
        </p:nvSpPr>
        <p:spPr>
          <a:xfrm>
            <a:off x="7029955" y="810781"/>
            <a:ext cx="9381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Met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Ra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982E820-14DB-7D5C-2FDC-674E4DD3983E}"/>
              </a:ext>
            </a:extLst>
          </p:cNvPr>
          <p:cNvSpPr txBox="1"/>
          <p:nvPr/>
        </p:nvSpPr>
        <p:spPr>
          <a:xfrm>
            <a:off x="7636188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8CC35EA-D82A-330E-4ABA-4EC94DA0D1A7}"/>
              </a:ext>
            </a:extLst>
          </p:cNvPr>
          <p:cNvSpPr txBox="1"/>
          <p:nvPr/>
        </p:nvSpPr>
        <p:spPr>
          <a:xfrm>
            <a:off x="8108035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E682B95-6A55-BBDE-8350-79CFC93921EB}"/>
              </a:ext>
            </a:extLst>
          </p:cNvPr>
          <p:cNvSpPr txBox="1"/>
          <p:nvPr/>
        </p:nvSpPr>
        <p:spPr>
          <a:xfrm>
            <a:off x="8562268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17BBD14-3DAA-F42C-B5FD-E5BD105C61AA}"/>
              </a:ext>
            </a:extLst>
          </p:cNvPr>
          <p:cNvSpPr txBox="1"/>
          <p:nvPr/>
        </p:nvSpPr>
        <p:spPr>
          <a:xfrm>
            <a:off x="8996752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EAFB152-94EB-6016-E0BC-52474A589940}"/>
              </a:ext>
            </a:extLst>
          </p:cNvPr>
          <p:cNvSpPr txBox="1"/>
          <p:nvPr/>
        </p:nvSpPr>
        <p:spPr>
          <a:xfrm>
            <a:off x="0" y="-3"/>
            <a:ext cx="3724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ll unedited blot/gel for Figure 2E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31483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D8662DF-2E79-49CD-CB9E-FADC0BC49D4B}"/>
              </a:ext>
            </a:extLst>
          </p:cNvPr>
          <p:cNvSpPr txBox="1"/>
          <p:nvPr/>
        </p:nvSpPr>
        <p:spPr>
          <a:xfrm>
            <a:off x="-26938" y="367183"/>
            <a:ext cx="4498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otal s6 ribosomal protein (32k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3568FA2-4B66-CD7A-1894-828ABBC7AE10}"/>
              </a:ext>
            </a:extLst>
          </p:cNvPr>
          <p:cNvSpPr txBox="1"/>
          <p:nvPr/>
        </p:nvSpPr>
        <p:spPr>
          <a:xfrm>
            <a:off x="957263" y="810781"/>
            <a:ext cx="9381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Met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Ra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811C5AD-1767-99FE-7DDD-C25F31937D81}"/>
              </a:ext>
            </a:extLst>
          </p:cNvPr>
          <p:cNvSpPr txBox="1"/>
          <p:nvPr/>
        </p:nvSpPr>
        <p:spPr>
          <a:xfrm>
            <a:off x="1563496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4F4733E-5343-FF60-077A-82F260D64257}"/>
              </a:ext>
            </a:extLst>
          </p:cNvPr>
          <p:cNvSpPr txBox="1"/>
          <p:nvPr/>
        </p:nvSpPr>
        <p:spPr>
          <a:xfrm>
            <a:off x="2035343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077287C-32AC-8004-7670-A6120F40BEA7}"/>
              </a:ext>
            </a:extLst>
          </p:cNvPr>
          <p:cNvSpPr txBox="1"/>
          <p:nvPr/>
        </p:nvSpPr>
        <p:spPr>
          <a:xfrm>
            <a:off x="2489576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CBBC250-E8A4-BBE5-9356-AFE5BE474FAC}"/>
              </a:ext>
            </a:extLst>
          </p:cNvPr>
          <p:cNvSpPr txBox="1"/>
          <p:nvPr/>
        </p:nvSpPr>
        <p:spPr>
          <a:xfrm>
            <a:off x="2924060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FE30F27-A2E9-28D4-D7B0-3DB1F0FBF296}"/>
              </a:ext>
            </a:extLst>
          </p:cNvPr>
          <p:cNvSpPr txBox="1"/>
          <p:nvPr/>
        </p:nvSpPr>
        <p:spPr>
          <a:xfrm>
            <a:off x="6607887" y="381004"/>
            <a:ext cx="5570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hospho-S6 Ribosomal Protein (Ser240/244) (</a:t>
            </a:r>
            <a:r>
              <a:rPr lang="en-US" altLang="ja-JP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32k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4BE8C09-9F67-35CC-EE06-B5BC8D602AC5}"/>
              </a:ext>
            </a:extLst>
          </p:cNvPr>
          <p:cNvSpPr txBox="1"/>
          <p:nvPr/>
        </p:nvSpPr>
        <p:spPr>
          <a:xfrm>
            <a:off x="6801352" y="810781"/>
            <a:ext cx="9381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Met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Ra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982E820-14DB-7D5C-2FDC-674E4DD3983E}"/>
              </a:ext>
            </a:extLst>
          </p:cNvPr>
          <p:cNvSpPr txBox="1"/>
          <p:nvPr/>
        </p:nvSpPr>
        <p:spPr>
          <a:xfrm>
            <a:off x="7407585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8CC35EA-D82A-330E-4ABA-4EC94DA0D1A7}"/>
              </a:ext>
            </a:extLst>
          </p:cNvPr>
          <p:cNvSpPr txBox="1"/>
          <p:nvPr/>
        </p:nvSpPr>
        <p:spPr>
          <a:xfrm>
            <a:off x="7879432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E682B95-6A55-BBDE-8350-79CFC93921EB}"/>
              </a:ext>
            </a:extLst>
          </p:cNvPr>
          <p:cNvSpPr txBox="1"/>
          <p:nvPr/>
        </p:nvSpPr>
        <p:spPr>
          <a:xfrm>
            <a:off x="8333665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17BBD14-3DAA-F42C-B5FD-E5BD105C61AA}"/>
              </a:ext>
            </a:extLst>
          </p:cNvPr>
          <p:cNvSpPr txBox="1"/>
          <p:nvPr/>
        </p:nvSpPr>
        <p:spPr>
          <a:xfrm>
            <a:off x="8768149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 descr="グラフ&#10;&#10;自動的に生成された説明">
            <a:extLst>
              <a:ext uri="{FF2B5EF4-FFF2-40B4-BE49-F238E27FC236}">
                <a16:creationId xmlns:a16="http://schemas.microsoft.com/office/drawing/2014/main" id="{919F25F9-1130-4F6F-0D1B-5F8D0D3C72B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5865" t="2332" r="23068" b="54698"/>
          <a:stretch/>
        </p:blipFill>
        <p:spPr>
          <a:xfrm>
            <a:off x="325365" y="1272446"/>
            <a:ext cx="6028075" cy="3600000"/>
          </a:xfrm>
          <a:prstGeom prst="rect">
            <a:avLst/>
          </a:prstGeom>
        </p:spPr>
      </p:pic>
      <p:pic>
        <p:nvPicPr>
          <p:cNvPr id="3" name="図 2" descr="グラフ&#10;&#10;自動的に生成された説明">
            <a:extLst>
              <a:ext uri="{FF2B5EF4-FFF2-40B4-BE49-F238E27FC236}">
                <a16:creationId xmlns:a16="http://schemas.microsoft.com/office/drawing/2014/main" id="{6BE6CF4E-3545-40F4-61BE-94A485B55F4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948" t="48481" r="21905" b="8550"/>
          <a:stretch/>
        </p:blipFill>
        <p:spPr>
          <a:xfrm>
            <a:off x="6353440" y="1272446"/>
            <a:ext cx="5838560" cy="3600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322153E-96AD-FD6F-B038-A5F512D4D259}"/>
              </a:ext>
            </a:extLst>
          </p:cNvPr>
          <p:cNvSpPr txBox="1"/>
          <p:nvPr/>
        </p:nvSpPr>
        <p:spPr>
          <a:xfrm>
            <a:off x="0" y="-3"/>
            <a:ext cx="3724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ll unedited blot/gel for Figure 2E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92431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D8662DF-2E79-49CD-CB9E-FADC0BC49D4B}"/>
              </a:ext>
            </a:extLst>
          </p:cNvPr>
          <p:cNvSpPr txBox="1"/>
          <p:nvPr/>
        </p:nvSpPr>
        <p:spPr>
          <a:xfrm>
            <a:off x="-26938" y="367183"/>
            <a:ext cx="4498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otal Akt (60k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FE30F27-A2E9-28D4-D7B0-3DB1F0FBF296}"/>
              </a:ext>
            </a:extLst>
          </p:cNvPr>
          <p:cNvSpPr txBox="1"/>
          <p:nvPr/>
        </p:nvSpPr>
        <p:spPr>
          <a:xfrm>
            <a:off x="5760001" y="367183"/>
            <a:ext cx="3288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Arial" panose="020B0604020202020204" pitchFamily="34" charset="0"/>
                <a:ea typeface="ＭＳ 明朝" panose="02020609040205080304" pitchFamily="49" charset="-128"/>
                <a:cs typeface="Arial" panose="020B0604020202020204" pitchFamily="34" charset="0"/>
              </a:rPr>
              <a:t>Phospho-Akt (Ser 473) </a:t>
            </a:r>
            <a:r>
              <a:rPr lang="en-US" altLang="ja-JP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(60k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4BE8C09-9F67-35CC-EE06-B5BC8D602AC5}"/>
              </a:ext>
            </a:extLst>
          </p:cNvPr>
          <p:cNvSpPr txBox="1"/>
          <p:nvPr/>
        </p:nvSpPr>
        <p:spPr>
          <a:xfrm>
            <a:off x="5972669" y="810781"/>
            <a:ext cx="9381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Met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Ra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982E820-14DB-7D5C-2FDC-674E4DD3983E}"/>
              </a:ext>
            </a:extLst>
          </p:cNvPr>
          <p:cNvSpPr txBox="1"/>
          <p:nvPr/>
        </p:nvSpPr>
        <p:spPr>
          <a:xfrm>
            <a:off x="6574284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8CC35EA-D82A-330E-4ABA-4EC94DA0D1A7}"/>
              </a:ext>
            </a:extLst>
          </p:cNvPr>
          <p:cNvSpPr txBox="1"/>
          <p:nvPr/>
        </p:nvSpPr>
        <p:spPr>
          <a:xfrm>
            <a:off x="6907587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E682B95-6A55-BBDE-8350-79CFC93921EB}"/>
              </a:ext>
            </a:extLst>
          </p:cNvPr>
          <p:cNvSpPr txBox="1"/>
          <p:nvPr/>
        </p:nvSpPr>
        <p:spPr>
          <a:xfrm>
            <a:off x="7287926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17BBD14-3DAA-F42C-B5FD-E5BD105C61AA}"/>
              </a:ext>
            </a:extLst>
          </p:cNvPr>
          <p:cNvSpPr txBox="1"/>
          <p:nvPr/>
        </p:nvSpPr>
        <p:spPr>
          <a:xfrm>
            <a:off x="7662376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D1A7C1CF-A17B-EEA1-8C3A-DE5D3DBA3F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054" t="3319" r="19474" b="59227"/>
          <a:stretch/>
        </p:blipFill>
        <p:spPr>
          <a:xfrm>
            <a:off x="1" y="1272446"/>
            <a:ext cx="5760000" cy="2929090"/>
          </a:xfrm>
          <a:prstGeom prst="rect">
            <a:avLst/>
          </a:prstGeom>
        </p:spPr>
      </p:pic>
      <p:pic>
        <p:nvPicPr>
          <p:cNvPr id="5" name="図 4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15CEE348-A8AB-D0BA-20F0-DE784C6583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053" t="45971" r="16908" b="16283"/>
          <a:stretch/>
        </p:blipFill>
        <p:spPr>
          <a:xfrm>
            <a:off x="5773570" y="1272446"/>
            <a:ext cx="5956468" cy="2932145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21428E7-8159-5C3C-2BC9-BE2C86B313FE}"/>
              </a:ext>
            </a:extLst>
          </p:cNvPr>
          <p:cNvSpPr txBox="1"/>
          <p:nvPr/>
        </p:nvSpPr>
        <p:spPr>
          <a:xfrm>
            <a:off x="40951" y="810781"/>
            <a:ext cx="9381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Met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Ra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24A5705-2873-FF8B-D565-42BD78AB1308}"/>
              </a:ext>
            </a:extLst>
          </p:cNvPr>
          <p:cNvSpPr txBox="1"/>
          <p:nvPr/>
        </p:nvSpPr>
        <p:spPr>
          <a:xfrm>
            <a:off x="642566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CAFC39F-7CE2-B2D2-EA2C-426A777A084C}"/>
              </a:ext>
            </a:extLst>
          </p:cNvPr>
          <p:cNvSpPr txBox="1"/>
          <p:nvPr/>
        </p:nvSpPr>
        <p:spPr>
          <a:xfrm>
            <a:off x="975869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6B30BF0-5010-B16C-72FF-D924F017C8FA}"/>
              </a:ext>
            </a:extLst>
          </p:cNvPr>
          <p:cNvSpPr txBox="1"/>
          <p:nvPr/>
        </p:nvSpPr>
        <p:spPr>
          <a:xfrm>
            <a:off x="1356208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CBD4A0B-639D-40E6-0470-1C23BB56DF7A}"/>
              </a:ext>
            </a:extLst>
          </p:cNvPr>
          <p:cNvSpPr txBox="1"/>
          <p:nvPr/>
        </p:nvSpPr>
        <p:spPr>
          <a:xfrm>
            <a:off x="1730658" y="810781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394255-242D-37D7-6ABA-6A41D163D6C4}"/>
              </a:ext>
            </a:extLst>
          </p:cNvPr>
          <p:cNvSpPr txBox="1"/>
          <p:nvPr/>
        </p:nvSpPr>
        <p:spPr>
          <a:xfrm>
            <a:off x="0" y="-3"/>
            <a:ext cx="3724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ll unedited blot/gel for Figure 2E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63786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ギター が含まれている画像&#10;&#10;自動的に生成された説明">
            <a:extLst>
              <a:ext uri="{FF2B5EF4-FFF2-40B4-BE49-F238E27FC236}">
                <a16:creationId xmlns:a16="http://schemas.microsoft.com/office/drawing/2014/main" id="{778DE35A-D5C9-F4A9-9D60-324EA3ED2B5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241" t="3866" r="20183" b="10566"/>
          <a:stretch/>
        </p:blipFill>
        <p:spPr>
          <a:xfrm>
            <a:off x="40951" y="1694184"/>
            <a:ext cx="5210347" cy="29268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C86A48F-EC1D-3389-19FE-8C974E505CC7}"/>
              </a:ext>
            </a:extLst>
          </p:cNvPr>
          <p:cNvSpPr txBox="1"/>
          <p:nvPr/>
        </p:nvSpPr>
        <p:spPr>
          <a:xfrm>
            <a:off x="498151" y="1158253"/>
            <a:ext cx="9381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Met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Ra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422E330-77B1-87CF-994E-B8DA032B9BBD}"/>
              </a:ext>
            </a:extLst>
          </p:cNvPr>
          <p:cNvSpPr txBox="1"/>
          <p:nvPr/>
        </p:nvSpPr>
        <p:spPr>
          <a:xfrm>
            <a:off x="1099766" y="1158253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CC4BA02-71D0-B7F1-A526-E0A5B04D26E2}"/>
              </a:ext>
            </a:extLst>
          </p:cNvPr>
          <p:cNvSpPr txBox="1"/>
          <p:nvPr/>
        </p:nvSpPr>
        <p:spPr>
          <a:xfrm>
            <a:off x="1433069" y="1158253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17A6F0D-EBC7-8737-CBE4-32A2AB65A443}"/>
              </a:ext>
            </a:extLst>
          </p:cNvPr>
          <p:cNvSpPr txBox="1"/>
          <p:nvPr/>
        </p:nvSpPr>
        <p:spPr>
          <a:xfrm>
            <a:off x="1813408" y="1158253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6F7C845-A12C-318A-5731-D1CEA87B1A4B}"/>
              </a:ext>
            </a:extLst>
          </p:cNvPr>
          <p:cNvSpPr txBox="1"/>
          <p:nvPr/>
        </p:nvSpPr>
        <p:spPr>
          <a:xfrm>
            <a:off x="2187858" y="1158253"/>
            <a:ext cx="6398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9589CF9-1CAB-4B26-D1BE-2611A7D07942}"/>
              </a:ext>
            </a:extLst>
          </p:cNvPr>
          <p:cNvSpPr txBox="1"/>
          <p:nvPr/>
        </p:nvSpPr>
        <p:spPr>
          <a:xfrm>
            <a:off x="0" y="-3"/>
            <a:ext cx="3724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ull unedited blot/gel for Figure 2E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77C83AE-9FC7-24F8-8146-A5278BD851AE}"/>
              </a:ext>
            </a:extLst>
          </p:cNvPr>
          <p:cNvSpPr txBox="1"/>
          <p:nvPr/>
        </p:nvSpPr>
        <p:spPr>
          <a:xfrm>
            <a:off x="-26938" y="367183"/>
            <a:ext cx="44989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PGC-1</a:t>
            </a:r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ɑ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 (120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kD)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GAPDH (37kD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9215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5</TotalTime>
  <Words>167</Words>
  <Application>Microsoft Macintosh PowerPoint</Application>
  <PresentationFormat>ワイド画面</PresentationFormat>
  <Paragraphs>82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e, Ryusuke</dc:creator>
  <cp:lastModifiedBy>Hatae, Ryusuke</cp:lastModifiedBy>
  <cp:revision>8</cp:revision>
  <dcterms:created xsi:type="dcterms:W3CDTF">2023-11-07T23:41:12Z</dcterms:created>
  <dcterms:modified xsi:type="dcterms:W3CDTF">2024-02-14T23:25:36Z</dcterms:modified>
</cp:coreProperties>
</file>